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2" d="100"/>
          <a:sy n="62" d="100"/>
        </p:scale>
        <p:origin x="114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67924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34168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7823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18941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811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87234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23409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74200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4635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64779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87246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EF9D1-F6FB-4A47-8526-FC8963412D51}" type="datetimeFigureOut">
              <a:rPr lang="en-CA" smtClean="0"/>
              <a:t>2019-02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66EC9-16B9-445C-B536-3F7A4BC2347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64621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1446" y="271557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z</a:t>
            </a:r>
            <a:endParaRPr lang="en-CA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11446" y="4551570"/>
            <a:ext cx="5597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Cz</a:t>
            </a:r>
            <a:endParaRPr lang="en-CA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1446" y="6458625"/>
            <a:ext cx="4347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z</a:t>
            </a:r>
            <a:endParaRPr lang="en-CA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00224" y="8376175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z</a:t>
            </a:r>
            <a:endParaRPr lang="en-CA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00224" y="10313129"/>
            <a:ext cx="4235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z</a:t>
            </a:r>
            <a:endParaRPr lang="en-CA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366739" y="205561"/>
            <a:ext cx="20349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dition Analysis</a:t>
            </a:r>
            <a:endParaRPr lang="en-CA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262334" y="205561"/>
            <a:ext cx="22401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ectation Analysis</a:t>
            </a:r>
            <a:endParaRPr lang="en-CA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47342" y="9648664"/>
            <a:ext cx="2785331" cy="166748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47342" y="7770702"/>
            <a:ext cx="2785331" cy="1667485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47342" y="5798267"/>
            <a:ext cx="2785331" cy="166748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47342" y="3916601"/>
            <a:ext cx="2785331" cy="166748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47342" y="2080604"/>
            <a:ext cx="2785331" cy="1667485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3909259" y="1128536"/>
            <a:ext cx="1222802" cy="246221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ECT WIN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758534" y="1349737"/>
            <a:ext cx="1373527" cy="246221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ECT LOSE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>
            <a:off x="5249353" y="1210481"/>
            <a:ext cx="338467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5259393" y="1455731"/>
            <a:ext cx="338467" cy="1"/>
          </a:xfrm>
          <a:prstGeom prst="line">
            <a:avLst/>
          </a:prstGeom>
          <a:ln w="254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054340" y="725912"/>
            <a:ext cx="801566" cy="400110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UAL WIN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>
            <a:off x="5966438" y="1209149"/>
            <a:ext cx="338467" cy="1"/>
          </a:xfrm>
          <a:prstGeom prst="line">
            <a:avLst/>
          </a:prstGeom>
          <a:ln w="2540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5976478" y="1454399"/>
            <a:ext cx="338467" cy="1"/>
          </a:xfrm>
          <a:prstGeom prst="line">
            <a:avLst/>
          </a:prstGeom>
          <a:ln w="2540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5732543" y="727376"/>
            <a:ext cx="831353" cy="400110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UAL LOSE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035706" y="1143503"/>
            <a:ext cx="1222802" cy="246221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IN &gt; LOSE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84981" y="1364704"/>
            <a:ext cx="1373527" cy="246221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IN = LOSE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884981" y="1601947"/>
            <a:ext cx="1373527" cy="246221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IN &lt; LOSE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/>
          <p:cNvCxnSpPr/>
          <p:nvPr/>
        </p:nvCxnSpPr>
        <p:spPr>
          <a:xfrm>
            <a:off x="2375800" y="1225448"/>
            <a:ext cx="338467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2385840" y="1470698"/>
            <a:ext cx="338467" cy="1"/>
          </a:xfrm>
          <a:prstGeom prst="line">
            <a:avLst/>
          </a:prstGeom>
          <a:ln w="254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2385840" y="1740025"/>
            <a:ext cx="338467" cy="1"/>
          </a:xfrm>
          <a:prstGeom prst="line">
            <a:avLst/>
          </a:prstGeom>
          <a:ln w="254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2291319" y="881554"/>
            <a:ext cx="538833" cy="246221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IN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>
            <a:off x="3092885" y="1224116"/>
            <a:ext cx="338467" cy="1"/>
          </a:xfrm>
          <a:prstGeom prst="line">
            <a:avLst/>
          </a:prstGeom>
          <a:ln w="2540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3102925" y="1469366"/>
            <a:ext cx="338467" cy="1"/>
          </a:xfrm>
          <a:prstGeom prst="line">
            <a:avLst/>
          </a:prstGeom>
          <a:ln w="2540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3102925" y="1738693"/>
            <a:ext cx="338467" cy="1"/>
          </a:xfrm>
          <a:prstGeom prst="line">
            <a:avLst/>
          </a:prstGeom>
          <a:ln w="25400">
            <a:solidFill>
              <a:schemeClr val="bg1">
                <a:lumMod val="5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2828846" y="883018"/>
            <a:ext cx="831353" cy="246221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SE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3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13020" y="2097223"/>
            <a:ext cx="2775010" cy="1661306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35706" y="3932385"/>
            <a:ext cx="2775010" cy="1661306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11529" y="5804446"/>
            <a:ext cx="2775010" cy="1661306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35706" y="7770765"/>
            <a:ext cx="2775010" cy="1661306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83524" y="9673174"/>
            <a:ext cx="2775010" cy="1661306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 rot="16200000">
            <a:off x="-334963" y="2867911"/>
            <a:ext cx="2406098" cy="215444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an Amplitude (</a:t>
            </a:r>
            <a:r>
              <a:rPr lang="en-GB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V</a:t>
            </a: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-318068" y="4704960"/>
            <a:ext cx="2406098" cy="215444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an Amplitude (</a:t>
            </a:r>
            <a:r>
              <a:rPr lang="en-GB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V</a:t>
            </a: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-361071" y="6459263"/>
            <a:ext cx="2406098" cy="215444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an Amplitude (</a:t>
            </a:r>
            <a:r>
              <a:rPr lang="en-GB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V</a:t>
            </a: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-330156" y="8493696"/>
            <a:ext cx="2406098" cy="215444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an Amplitude (</a:t>
            </a:r>
            <a:r>
              <a:rPr lang="en-GB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V</a:t>
            </a: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6200000">
            <a:off x="-343474" y="10453116"/>
            <a:ext cx="2406098" cy="215444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an Amplitude (</a:t>
            </a:r>
            <a:r>
              <a:rPr lang="en-GB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V</a:t>
            </a: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3865807" y="1952002"/>
            <a:ext cx="252513" cy="943146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7" name="TextBox 46"/>
          <p:cNvSpPr txBox="1"/>
          <p:nvPr/>
        </p:nvSpPr>
        <p:spPr>
          <a:xfrm>
            <a:off x="1250834" y="11599154"/>
            <a:ext cx="2406098" cy="215444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GB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768373" y="11372349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20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231016" y="11381964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709037" y="11379910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767083" y="11374634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299771" y="11368091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228228" y="11373726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255968" y="11593514"/>
            <a:ext cx="2406098" cy="215444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</a:t>
            </a:r>
            <a:r>
              <a:rPr lang="en-GB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773507" y="11366709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20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236150" y="11376324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714171" y="11374270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772217" y="11368994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6304905" y="11362451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233362" y="11368086"/>
            <a:ext cx="790745" cy="200055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en-GB" sz="7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16879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</TotalTime>
  <Words>75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8</cp:revision>
  <dcterms:created xsi:type="dcterms:W3CDTF">2018-11-07T21:13:58Z</dcterms:created>
  <dcterms:modified xsi:type="dcterms:W3CDTF">2019-02-12T20:19:05Z</dcterms:modified>
</cp:coreProperties>
</file>